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796088" cy="98742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874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1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2" name="AutoShape 1"/>
          <p:cNvSpPr/>
          <p:nvPr/>
        </p:nvSpPr>
        <p:spPr>
          <a:xfrm>
            <a:off x="0" y="0"/>
            <a:ext cx="6796080" cy="9874080"/>
          </a:xfrm>
          <a:custGeom>
            <a:avLst/>
            <a:gdLst>
              <a:gd name="textAreaLeft" fmla="*/ 360 w 6796080"/>
              <a:gd name="textAreaRight" fmla="*/ 6795720 w 6796080"/>
              <a:gd name="textAreaTop" fmla="*/ 360 h 9874080"/>
              <a:gd name="textAreaBottom" fmla="*/ 9873720 h 9874080"/>
            </a:gdLst>
            <a:ahLst/>
            <a:rect l="textAreaLeft" t="textAreaTop" r="textAreaRight" b="textAreaBottom"/>
            <a:pathLst>
              <a:path w="21600" h="31382">
                <a:moveTo>
                  <a:pt x="5" y="0"/>
                </a:moveTo>
                <a:arcTo wR="5" hR="5" stAng="16200000" swAng="-5400000"/>
                <a:lnTo>
                  <a:pt x="0" y="31377"/>
                </a:lnTo>
                <a:arcTo wR="5" hR="5" stAng="10800000" swAng="-5400000"/>
                <a:lnTo>
                  <a:pt x="21595" y="31382"/>
                </a:lnTo>
                <a:arcTo wR="5" hR="5" stAng="5400000" swAng="-5400000"/>
                <a:lnTo>
                  <a:pt x="21600" y="5"/>
                </a:lnTo>
                <a:arcTo wR="5" hR="5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1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3" name="Text Box 2"/>
          <p:cNvSpPr/>
          <p:nvPr/>
        </p:nvSpPr>
        <p:spPr>
          <a:xfrm>
            <a:off x="0" y="0"/>
            <a:ext cx="29462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1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4" name="PlaceHolder 1"/>
          <p:cNvSpPr>
            <a:spLocks noGrp="1"/>
          </p:cNvSpPr>
          <p:nvPr>
            <p:ph type="dt" idx="2"/>
          </p:nvPr>
        </p:nvSpPr>
        <p:spPr>
          <a:xfrm>
            <a:off x="3849840" y="-360"/>
            <a:ext cx="2944800" cy="49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1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 type="sldImg"/>
          </p:nvPr>
        </p:nvSpPr>
        <p:spPr>
          <a:xfrm>
            <a:off x="2117880" y="740880"/>
            <a:ext cx="2560320" cy="37004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3"/>
          <p:cNvSpPr>
            <a:spLocks noGrp="1"/>
          </p:cNvSpPr>
          <p:nvPr>
            <p:ph type="body"/>
          </p:nvPr>
        </p:nvSpPr>
        <p:spPr>
          <a:xfrm>
            <a:off x="679320" y="4691160"/>
            <a:ext cx="5437440" cy="4441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Text Box 6"/>
          <p:cNvSpPr/>
          <p:nvPr/>
        </p:nvSpPr>
        <p:spPr>
          <a:xfrm>
            <a:off x="0" y="9379080"/>
            <a:ext cx="29462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1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" name="PlaceHolder 4"/>
          <p:cNvSpPr>
            <a:spLocks noGrp="1"/>
          </p:cNvSpPr>
          <p:nvPr>
            <p:ph type="sldNum" idx="3"/>
          </p:nvPr>
        </p:nvSpPr>
        <p:spPr>
          <a:xfrm>
            <a:off x="3849840" y="9378720"/>
            <a:ext cx="2944800" cy="49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1" lang="de-DE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0AF5AD3D-1115-43D0-8215-97CECC946DE3}" type="slidenum">
              <a:rPr b="1" lang="de-DE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2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Rectangle 7"/>
          <p:cNvSpPr/>
          <p:nvPr/>
        </p:nvSpPr>
        <p:spPr>
          <a:xfrm>
            <a:off x="3849840" y="9379080"/>
            <a:ext cx="2944800" cy="492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D4935CD5-5DDF-4908-9362-C3D571BC5FB9}" type="slidenum">
              <a:rPr b="1" lang="de-DE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6" name="PlaceHolder 1"/>
          <p:cNvSpPr>
            <a:spLocks noGrp="1"/>
          </p:cNvSpPr>
          <p:nvPr>
            <p:ph type="sldImg"/>
          </p:nvPr>
        </p:nvSpPr>
        <p:spPr>
          <a:xfrm>
            <a:off x="2117880" y="741240"/>
            <a:ext cx="2562120" cy="3702240"/>
          </a:xfrm>
          <a:prstGeom prst="rect">
            <a:avLst/>
          </a:prstGeom>
          <a:ln w="0">
            <a:noFill/>
          </a:ln>
        </p:spPr>
      </p:sp>
      <p:sp>
        <p:nvSpPr>
          <p:cNvPr id="57" name="PlaceHolder 2"/>
          <p:cNvSpPr>
            <a:spLocks noGrp="1"/>
          </p:cNvSpPr>
          <p:nvPr>
            <p:ph type="body"/>
          </p:nvPr>
        </p:nvSpPr>
        <p:spPr>
          <a:xfrm>
            <a:off x="679320" y="4690800"/>
            <a:ext cx="5438880" cy="4443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5F146BF-8824-49D4-9195-1A20BFB69D72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582768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965560"/>
            <a:ext cx="582768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05080B8-C280-4D08-8940-DA6DB05D7CDC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0640" y="286200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96556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0640" y="596556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29C5038D-3E11-4404-A150-AF3542A2B7F2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187632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080" y="2862000"/>
            <a:ext cx="187632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5360" y="2862000"/>
            <a:ext cx="187632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965560"/>
            <a:ext cx="187632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080" y="5965560"/>
            <a:ext cx="187632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5360" y="5965560"/>
            <a:ext cx="187632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0CCED8F5-AFED-4EB3-BB67-AE8CBEC6A6F8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862000"/>
            <a:ext cx="5827680" cy="5941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D1B3374A-D0C0-42CF-81E8-FA7CFB896B08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5827680" cy="59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28E2AEA2-3161-4EE9-83F5-930AAB69D192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2843640" cy="59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0640" y="2862000"/>
            <a:ext cx="2843640" cy="59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4F9E07C1-D269-4079-AEF7-5F9D9AC72548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8E63BFF8-F5A9-4908-840F-1AA87A1EA3E5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80920"/>
            <a:ext cx="5827680" cy="764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E077356-0666-43E2-B2ED-42DD31AE6242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0640" y="2862000"/>
            <a:ext cx="2843640" cy="59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96556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B84F110D-D021-4227-BD07-2D4DCF771195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2843640" cy="59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0640" y="286200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0640" y="596556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3F035F7A-D8C8-4993-B986-BF8881C70C73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0640" y="286200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965560"/>
            <a:ext cx="582768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0B2E4E1-259D-4CCB-961F-1EC781F132A1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862000"/>
            <a:ext cx="5827680" cy="59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Text Box 3"/>
          <p:cNvSpPr/>
          <p:nvPr/>
        </p:nvSpPr>
        <p:spPr>
          <a:xfrm>
            <a:off x="514440" y="9024840"/>
            <a:ext cx="1428840" cy="66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1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Text Box 4"/>
          <p:cNvSpPr/>
          <p:nvPr/>
        </p:nvSpPr>
        <p:spPr>
          <a:xfrm>
            <a:off x="2343240" y="9024840"/>
            <a:ext cx="2171520" cy="66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1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>
          <a:xfrm>
            <a:off x="4915080" y="9024840"/>
            <a:ext cx="1427040" cy="65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2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9CA4BF2E-4370-4458-809E-43E5F3357694}" type="slidenum">
              <a:rPr b="0" lang="en-US" sz="2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24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Rectangle 1"/>
          <p:cNvSpPr/>
          <p:nvPr/>
        </p:nvSpPr>
        <p:spPr>
          <a:xfrm>
            <a:off x="549360" y="200160"/>
            <a:ext cx="5829120" cy="165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</a:rPr>
              <a:t>Supplementary Figure S2</a:t>
            </a:r>
            <a:br>
              <a:rPr sz="3200"/>
            </a:br>
            <a:endParaRPr b="1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0" name="Text Box 2"/>
          <p:cNvSpPr/>
          <p:nvPr/>
        </p:nvSpPr>
        <p:spPr>
          <a:xfrm>
            <a:off x="1506240" y="1568520"/>
            <a:ext cx="42969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down-regulation of miRNA-1</a:t>
            </a:r>
            <a:endParaRPr b="1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" name="Text Box 3"/>
          <p:cNvSpPr/>
          <p:nvPr/>
        </p:nvSpPr>
        <p:spPr>
          <a:xfrm>
            <a:off x="1718640" y="4851360"/>
            <a:ext cx="38732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up-regulation of miRNA-1</a:t>
            </a:r>
            <a:endParaRPr b="1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pic>
        <p:nvPicPr>
          <p:cNvPr id="52" name="Picture 4" descr=""/>
          <p:cNvPicPr/>
          <p:nvPr/>
        </p:nvPicPr>
        <p:blipFill>
          <a:blip r:embed="rId1"/>
          <a:stretch/>
        </p:blipFill>
        <p:spPr>
          <a:xfrm>
            <a:off x="219240" y="2076480"/>
            <a:ext cx="6454440" cy="247788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5" descr=""/>
          <p:cNvPicPr/>
          <p:nvPr/>
        </p:nvPicPr>
        <p:blipFill>
          <a:blip r:embed="rId2"/>
          <a:stretch/>
        </p:blipFill>
        <p:spPr>
          <a:xfrm>
            <a:off x="222120" y="5437080"/>
            <a:ext cx="6454800" cy="2478240"/>
          </a:xfrm>
          <a:prstGeom prst="rect">
            <a:avLst/>
          </a:prstGeom>
          <a:ln w="0">
            <a:noFill/>
          </a:ln>
        </p:spPr>
      </p:pic>
      <p:sp>
        <p:nvSpPr>
          <p:cNvPr id="54" name="TextBox 1"/>
          <p:cNvSpPr/>
          <p:nvPr/>
        </p:nvSpPr>
        <p:spPr>
          <a:xfrm>
            <a:off x="260280" y="8194680"/>
            <a:ext cx="6337440" cy="1265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Figure S2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. Modeling of the miRNA down- and upregulation in metastasis tissues of patient 3,4,5 and 7. miRNA-1 was either down-regulated 1.01-, 1.1-, 1.2-, 1.4-, 1.6-, 1.8-, 2-, 4-, 10-, 20- and 100fold (top row) or increased 1.01-, 1.1-, 1.2-, 1.4-, 1.6-, 1.8-, 2-, 4-, 10, 20- and 100fold (bottom row) and component concentration changes counted in a dose-dependent manner. The number of pre-selected components in ten different groups, as determined according to figure 6C, at different miRNA-1 concentrations are visualized as scatter plots. </a:t>
            </a:r>
            <a:endParaRPr b="1" lang="en-US" sz="1100" spc="-1" strike="noStrike">
              <a:solidFill>
                <a:srgbClr val="ffffff"/>
              </a:solidFill>
              <a:latin typeface="Arial"/>
            </a:endParaRPr>
          </a:p>
          <a:p>
            <a:pPr algn="just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1" lang="en-US" sz="11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0-08T07:41:36Z</dcterms:created>
  <dc:creator>MPIMG MPIMG</dc:creator>
  <dc:description/>
  <dc:language>en-US</dc:language>
  <cp:lastModifiedBy>MPIMG MPIMG</cp:lastModifiedBy>
  <cp:lastPrinted>2011-10-11T10:07:43Z</cp:lastPrinted>
  <dcterms:modified xsi:type="dcterms:W3CDTF">2013-06-06T20:46:58Z</dcterms:modified>
  <cp:revision>184</cp:revision>
  <dc:subject/>
  <dc:title>Figure 1</dc:title>
</cp:coreProperties>
</file>